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04" d="100"/>
          <a:sy n="104" d="100"/>
        </p:scale>
        <p:origin x="232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4120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161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0642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6138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6036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5224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9342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28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3687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387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0770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A6FC8D-07AD-4527-84A4-117D32C63664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4C9B18-B041-4751-BF83-A0A8C37270B4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1331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21D55038-41CF-C77B-66B1-F08380277735}"/>
              </a:ext>
            </a:extLst>
          </p:cNvPr>
          <p:cNvGrpSpPr/>
          <p:nvPr/>
        </p:nvGrpSpPr>
        <p:grpSpPr>
          <a:xfrm>
            <a:off x="1056000" y="193184"/>
            <a:ext cx="10080000" cy="6471633"/>
            <a:chOff x="804553" y="261147"/>
            <a:chExt cx="10080000" cy="6471633"/>
          </a:xfrm>
        </p:grpSpPr>
        <p:sp>
          <p:nvSpPr>
            <p:cNvPr id="6" name="Rettangolo 5"/>
            <p:cNvSpPr/>
            <p:nvPr/>
          </p:nvSpPr>
          <p:spPr>
            <a:xfrm>
              <a:off x="804553" y="261147"/>
              <a:ext cx="1008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/>
              <a:r>
                <a:rPr lang="en-GB" sz="1600" kern="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xternal validation of the J-ACCESS model underestimate risk observed in our patients undergoing stress myocardial perfusion imaging. The adaptation of the model is better by logistic recalibration </a:t>
              </a:r>
              <a:endParaRPr kumimoji="0" lang="en-GB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Immagine 1">
              <a:extLst>
                <a:ext uri="{FF2B5EF4-FFF2-40B4-BE49-F238E27FC236}">
                  <a16:creationId xmlns:a16="http://schemas.microsoft.com/office/drawing/2014/main" id="{92265E96-3AA3-0A8F-4C99-7A72B39611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04553" y="972780"/>
              <a:ext cx="4940400" cy="5760000"/>
            </a:xfrm>
            <a:prstGeom prst="rect">
              <a:avLst/>
            </a:prstGeom>
          </p:spPr>
        </p:pic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9801A1EE-C4EE-68B4-5B58-678F6F75FBB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44153" y="972780"/>
              <a:ext cx="4940400" cy="57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707235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28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sario Megna</dc:creator>
  <cp:lastModifiedBy>ALBERTO CUOCOLO</cp:lastModifiedBy>
  <cp:revision>8</cp:revision>
  <dcterms:created xsi:type="dcterms:W3CDTF">2022-10-24T07:53:50Z</dcterms:created>
  <dcterms:modified xsi:type="dcterms:W3CDTF">2022-11-04T15:59:20Z</dcterms:modified>
</cp:coreProperties>
</file>